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DE92E-8B00-4876-B695-770465A681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2382D-8F3C-4D0B-B77A-F90B44E251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9CA5E-65A2-47AA-8F14-E4DD2BEF4E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C6AF3-0A45-4D0D-96B0-FA75C9C0F7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2123D-E044-44B0-8908-FE47852003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7ED631-B871-4C36-AC69-9783B487DA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3E8BC0-EF0B-4CE9-8FE8-E10544207A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15024-472C-4602-A820-6260ABAFE6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4E171-8125-429B-AADA-B329057842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4E9FD-170D-45DA-B9E5-BE1A87CC2B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92A50-06DB-40F0-8DA0-1295067364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352BFE-3DBE-41F2-A77A-BB93C8E6F0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C91EEC-7A80-45F4-A7F8-EF9B3F5511D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62120" y="1066680"/>
            <a:ext cx="5057640" cy="4089240"/>
            <a:chOff x="762120" y="1066680"/>
            <a:chExt cx="5057640" cy="4089240"/>
          </a:xfrm>
        </p:grpSpPr>
        <p:grpSp>
          <p:nvGrpSpPr>
            <p:cNvPr id="42" name=""/>
            <p:cNvGrpSpPr/>
            <p:nvPr/>
          </p:nvGrpSpPr>
          <p:grpSpPr>
            <a:xfrm>
              <a:off x="762120" y="1066680"/>
              <a:ext cx="4849560" cy="888480"/>
              <a:chOff x="762120" y="1066680"/>
              <a:chExt cx="4849560" cy="888480"/>
            </a:xfrm>
          </p:grpSpPr>
          <p:sp>
            <p:nvSpPr>
              <p:cNvPr id="43" name=""/>
              <p:cNvSpPr/>
              <p:nvPr/>
            </p:nvSpPr>
            <p:spPr>
              <a:xfrm>
                <a:off x="762120" y="1066680"/>
                <a:ext cx="284760" cy="229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58680" rIns="58680" tIns="29160" bIns="29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(A)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"/>
              <p:cNvGrpSpPr/>
              <p:nvPr/>
            </p:nvGrpSpPr>
            <p:grpSpPr>
              <a:xfrm>
                <a:off x="890640" y="1220760"/>
                <a:ext cx="4721040" cy="734400"/>
                <a:chOff x="890640" y="1220760"/>
                <a:chExt cx="4721040" cy="734400"/>
              </a:xfrm>
            </p:grpSpPr>
            <p:sp>
              <p:nvSpPr>
                <p:cNvPr id="45" name=""/>
                <p:cNvSpPr/>
                <p:nvPr/>
              </p:nvSpPr>
              <p:spPr>
                <a:xfrm>
                  <a:off x="890640" y="1253520"/>
                  <a:ext cx="390960" cy="178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5880" rIns="65880" tIns="32760" bIns="327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Sal</a:t>
                  </a:r>
                  <a:r>
                    <a:rPr b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6" name=""/>
                <p:cNvGrpSpPr/>
                <p:nvPr/>
              </p:nvGrpSpPr>
              <p:grpSpPr>
                <a:xfrm>
                  <a:off x="905760" y="1696680"/>
                  <a:ext cx="3846240" cy="57960"/>
                  <a:chOff x="905760" y="1696680"/>
                  <a:chExt cx="3846240" cy="57960"/>
                </a:xfrm>
              </p:grpSpPr>
              <p:sp>
                <p:nvSpPr>
                  <p:cNvPr id="47" name=""/>
                  <p:cNvSpPr/>
                  <p:nvPr/>
                </p:nvSpPr>
                <p:spPr>
                  <a:xfrm>
                    <a:off x="905760" y="1696680"/>
                    <a:ext cx="3846240" cy="0"/>
                  </a:xfrm>
                  <a:prstGeom prst="line">
                    <a:avLst/>
                  </a:prstGeom>
                  <a:ln w="9360">
                    <a:solidFill>
                      <a:srgbClr val="ff99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" name=""/>
                  <p:cNvSpPr/>
                  <p:nvPr/>
                </p:nvSpPr>
                <p:spPr>
                  <a:xfrm>
                    <a:off x="905760" y="1754640"/>
                    <a:ext cx="3846240" cy="0"/>
                  </a:xfrm>
                  <a:prstGeom prst="line">
                    <a:avLst/>
                  </a:prstGeom>
                  <a:ln w="9360">
                    <a:solidFill>
                      <a:srgbClr val="ff99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9" name=""/>
                <p:cNvSpPr/>
                <p:nvPr/>
              </p:nvSpPr>
              <p:spPr>
                <a:xfrm>
                  <a:off x="1053360" y="1506960"/>
                  <a:ext cx="1468080" cy="448200"/>
                </a:xfrm>
                <a:prstGeom prst="rightArrow">
                  <a:avLst>
                    <a:gd name="adj1" fmla="val 50000"/>
                    <a:gd name="adj2" fmla="val 81888"/>
                  </a:avLst>
                </a:prstGeom>
                <a:solidFill>
                  <a:srgbClr val="00cc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5880" rIns="65880" tIns="32760" bIns="3276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"/>
                <p:cNvSpPr/>
                <p:nvPr/>
              </p:nvSpPr>
              <p:spPr>
                <a:xfrm>
                  <a:off x="4725360" y="1579680"/>
                  <a:ext cx="886320" cy="219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5880" rIns="65880" tIns="32760" bIns="327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cc3300"/>
                      </a:solidFill>
                      <a:latin typeface="Times New Roman"/>
                      <a:ea typeface="SimSun"/>
                    </a:rPr>
                    <a:t>pCAMBIA13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>
                  <a:off x="2530080" y="1530360"/>
                  <a:ext cx="1166400" cy="390960"/>
                </a:xfrm>
                <a:prstGeom prst="rightArrow">
                  <a:avLst>
                    <a:gd name="adj1" fmla="val 50000"/>
                    <a:gd name="adj2" fmla="val 74586"/>
                  </a:avLst>
                </a:prstGeom>
                <a:solidFill>
                  <a:srgbClr val="99ff3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5880" rIns="65880" tIns="32760" bIns="3276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100" spc="-1" strike="noStrike">
                      <a:solidFill>
                        <a:srgbClr val="ff00ff"/>
                      </a:solidFill>
                      <a:latin typeface="Times New Roman"/>
                      <a:ea typeface="SimSun"/>
                    </a:rPr>
                    <a:t>sGFP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3729240" y="1551960"/>
                  <a:ext cx="537840" cy="338040"/>
                </a:xfrm>
                <a:prstGeom prst="rect">
                  <a:avLst/>
                </a:prstGeom>
                <a:solidFill>
                  <a:srgbClr val="ff3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5880" rIns="65880" tIns="32760" bIns="3276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100" spc="-1" strike="noStrike">
                      <a:solidFill>
                        <a:srgbClr val="ffff66"/>
                      </a:solidFill>
                      <a:latin typeface="Times New Roman"/>
                      <a:ea typeface="SimSun"/>
                    </a:rPr>
                    <a:t>NOS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>
                  <a:off x="4135680" y="1244160"/>
                  <a:ext cx="329400" cy="187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5880" rIns="65880" tIns="32760" bIns="327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Sac</a:t>
                  </a:r>
                  <a:r>
                    <a:rPr b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"/>
                <p:cNvSpPr/>
                <p:nvPr/>
              </p:nvSpPr>
              <p:spPr>
                <a:xfrm>
                  <a:off x="1058040" y="1598400"/>
                  <a:ext cx="1153440" cy="264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5880" rIns="65880" tIns="32760" bIns="327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100" spc="-1" strike="noStrike">
                      <a:solidFill>
                        <a:srgbClr val="ffff66"/>
                      </a:solidFill>
                      <a:latin typeface="Times New Roman"/>
                      <a:ea typeface="SimSun"/>
                    </a:rPr>
                    <a:t>OsCYP96B4</a:t>
                  </a:r>
                  <a:r>
                    <a:rPr b="1" lang="en-US" sz="1100" spc="-1" strike="noStrike">
                      <a:solidFill>
                        <a:srgbClr val="ffff66"/>
                      </a:solidFill>
                      <a:latin typeface="Times New Roman"/>
                      <a:ea typeface="SimSun"/>
                    </a:rPr>
                    <a:t>-Pro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2358720" y="1220760"/>
                  <a:ext cx="388440" cy="169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5880" rIns="65880" tIns="32760" bIns="327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Nco</a:t>
                  </a:r>
                  <a:r>
                    <a:rPr b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3523680" y="1234440"/>
                  <a:ext cx="377280" cy="206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5880" rIns="65880" tIns="32760" bIns="327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Not</a:t>
                  </a:r>
                  <a:r>
                    <a:rPr b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 flipV="1">
                  <a:off x="1037880" y="1391400"/>
                  <a:ext cx="0" cy="308520"/>
                </a:xfrm>
                <a:prstGeom prst="line">
                  <a:avLst/>
                </a:prstGeom>
                <a:ln w="381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 flipV="1">
                  <a:off x="2513160" y="1378440"/>
                  <a:ext cx="0" cy="307080"/>
                </a:xfrm>
                <a:prstGeom prst="line">
                  <a:avLst/>
                </a:prstGeom>
                <a:ln w="381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 flipV="1">
                  <a:off x="3696840" y="1393920"/>
                  <a:ext cx="0" cy="301680"/>
                </a:xfrm>
                <a:prstGeom prst="line">
                  <a:avLst/>
                </a:prstGeom>
                <a:ln w="381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 flipV="1">
                  <a:off x="4291560" y="1388880"/>
                  <a:ext cx="0" cy="306360"/>
                </a:xfrm>
                <a:prstGeom prst="line">
                  <a:avLst/>
                </a:prstGeom>
                <a:ln w="381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61" name=""/>
            <p:cNvGrpSpPr/>
            <p:nvPr/>
          </p:nvGrpSpPr>
          <p:grpSpPr>
            <a:xfrm>
              <a:off x="762120" y="2041200"/>
              <a:ext cx="4902120" cy="1171440"/>
              <a:chOff x="762120" y="2041200"/>
              <a:chExt cx="4902120" cy="1171440"/>
            </a:xfrm>
          </p:grpSpPr>
          <p:sp>
            <p:nvSpPr>
              <p:cNvPr id="62" name=""/>
              <p:cNvSpPr/>
              <p:nvPr/>
            </p:nvSpPr>
            <p:spPr>
              <a:xfrm>
                <a:off x="762120" y="2068560"/>
                <a:ext cx="285120" cy="229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58680" rIns="58680" tIns="29160" bIns="29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(B)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3" name=""/>
              <p:cNvGrpSpPr/>
              <p:nvPr/>
            </p:nvGrpSpPr>
            <p:grpSpPr>
              <a:xfrm>
                <a:off x="781200" y="2041200"/>
                <a:ext cx="4883040" cy="1171440"/>
                <a:chOff x="781200" y="2041200"/>
                <a:chExt cx="4883040" cy="1171440"/>
              </a:xfrm>
            </p:grpSpPr>
            <p:sp>
              <p:nvSpPr>
                <p:cNvPr id="64" name=""/>
                <p:cNvSpPr/>
                <p:nvPr/>
              </p:nvSpPr>
              <p:spPr>
                <a:xfrm flipV="1">
                  <a:off x="3868920" y="2259720"/>
                  <a:ext cx="199080" cy="385200"/>
                </a:xfrm>
                <a:prstGeom prst="line">
                  <a:avLst/>
                </a:prstGeom>
                <a:ln w="28440">
                  <a:solidFill>
                    <a:srgbClr val="cc33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 flipV="1">
                  <a:off x="4026600" y="2369160"/>
                  <a:ext cx="489600" cy="256680"/>
                </a:xfrm>
                <a:prstGeom prst="line">
                  <a:avLst/>
                </a:prstGeom>
                <a:ln w="28440">
                  <a:solidFill>
                    <a:srgbClr val="ff33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6" name=""/>
                <p:cNvGrpSpPr/>
                <p:nvPr/>
              </p:nvGrpSpPr>
              <p:grpSpPr>
                <a:xfrm>
                  <a:off x="781200" y="2041200"/>
                  <a:ext cx="4883040" cy="1171440"/>
                  <a:chOff x="781200" y="2041200"/>
                  <a:chExt cx="4883040" cy="1171440"/>
                </a:xfrm>
              </p:grpSpPr>
              <p:grpSp>
                <p:nvGrpSpPr>
                  <p:cNvPr id="67" name=""/>
                  <p:cNvGrpSpPr/>
                  <p:nvPr/>
                </p:nvGrpSpPr>
                <p:grpSpPr>
                  <a:xfrm>
                    <a:off x="781200" y="2041200"/>
                    <a:ext cx="4883040" cy="1171440"/>
                    <a:chOff x="781200" y="2041200"/>
                    <a:chExt cx="4883040" cy="1171440"/>
                  </a:xfrm>
                </p:grpSpPr>
                <p:sp>
                  <p:nvSpPr>
                    <p:cNvPr id="68" name=""/>
                    <p:cNvSpPr/>
                    <p:nvPr/>
                  </p:nvSpPr>
                  <p:spPr>
                    <a:xfrm>
                      <a:off x="3930480" y="2041200"/>
                      <a:ext cx="660240" cy="263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64800" rIns="64800" tIns="32400" bIns="324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100" spc="-1" strike="noStrike">
                          <a:solidFill>
                            <a:srgbClr val="cc3300"/>
                          </a:solidFill>
                          <a:latin typeface="Times New Roman"/>
                          <a:ea typeface="SimSun"/>
                        </a:rPr>
                        <a:t>c-my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" name=""/>
                    <p:cNvSpPr/>
                    <p:nvPr/>
                  </p:nvSpPr>
                  <p:spPr>
                    <a:xfrm>
                      <a:off x="3567960" y="2305800"/>
                      <a:ext cx="365760" cy="172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64800" rIns="64800" tIns="32400" bIns="324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800" spc="-1" strike="noStrike">
                          <a:solidFill>
                            <a:srgbClr val="33cc33"/>
                          </a:solidFill>
                          <a:latin typeface="Times New Roman"/>
                          <a:ea typeface="SimSun"/>
                        </a:rPr>
                        <a:t>Spe</a:t>
                      </a:r>
                      <a:r>
                        <a:rPr b="1" lang="en-US" sz="800" spc="-1" strike="noStrike">
                          <a:solidFill>
                            <a:srgbClr val="33cc33"/>
                          </a:solidFill>
                          <a:latin typeface="Times New Roman"/>
                          <a:ea typeface="SimSun"/>
                        </a:rPr>
                        <a:t>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" name=""/>
                    <p:cNvSpPr/>
                    <p:nvPr/>
                  </p:nvSpPr>
                  <p:spPr>
                    <a:xfrm>
                      <a:off x="781200" y="2305800"/>
                      <a:ext cx="527760" cy="199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64800" rIns="64800" tIns="32400" bIns="324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800" spc="-1" strike="noStrike">
                          <a:solidFill>
                            <a:srgbClr val="33cc33"/>
                          </a:solidFill>
                          <a:latin typeface="Times New Roman"/>
                          <a:ea typeface="SimSun"/>
                        </a:rPr>
                        <a:t>Hin</a:t>
                      </a:r>
                      <a:r>
                        <a:rPr b="1" lang="en-US" sz="800" spc="-1" strike="noStrike">
                          <a:solidFill>
                            <a:srgbClr val="33cc33"/>
                          </a:solidFill>
                          <a:latin typeface="Times New Roman"/>
                          <a:ea typeface="SimSun"/>
                        </a:rPr>
                        <a:t>dII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71" name=""/>
                    <p:cNvGrpSpPr/>
                    <p:nvPr/>
                  </p:nvGrpSpPr>
                  <p:grpSpPr>
                    <a:xfrm>
                      <a:off x="880920" y="2754360"/>
                      <a:ext cx="3969000" cy="67320"/>
                      <a:chOff x="880920" y="2754360"/>
                      <a:chExt cx="3969000" cy="67320"/>
                    </a:xfrm>
                  </p:grpSpPr>
                  <p:sp>
                    <p:nvSpPr>
                      <p:cNvPr id="72" name=""/>
                      <p:cNvSpPr/>
                      <p:nvPr/>
                    </p:nvSpPr>
                    <p:spPr>
                      <a:xfrm>
                        <a:off x="880920" y="2821320"/>
                        <a:ext cx="3969000" cy="360"/>
                      </a:xfrm>
                      <a:prstGeom prst="line">
                        <a:avLst/>
                      </a:prstGeom>
                      <a:ln w="9360">
                        <a:solidFill>
                          <a:srgbClr val="ff99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440" bIns="-4644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73" name=""/>
                      <p:cNvSpPr/>
                      <p:nvPr/>
                    </p:nvSpPr>
                    <p:spPr>
                      <a:xfrm>
                        <a:off x="880920" y="2754360"/>
                        <a:ext cx="3969000" cy="720"/>
                      </a:xfrm>
                      <a:prstGeom prst="line">
                        <a:avLst/>
                      </a:prstGeom>
                      <a:ln w="9360">
                        <a:solidFill>
                          <a:srgbClr val="ff99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74" name=""/>
                    <p:cNvSpPr/>
                    <p:nvPr/>
                  </p:nvSpPr>
                  <p:spPr>
                    <a:xfrm>
                      <a:off x="1029600" y="2558520"/>
                      <a:ext cx="1493640" cy="471240"/>
                    </a:xfrm>
                    <a:prstGeom prst="rightArrow">
                      <a:avLst>
                        <a:gd name="adj1" fmla="val 50000"/>
                        <a:gd name="adj2" fmla="val 79240"/>
                      </a:avLst>
                    </a:prstGeom>
                    <a:solidFill>
                      <a:srgbClr val="00cc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64800" rIns="64800" tIns="32400" bIns="324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66"/>
                          </a:solidFill>
                          <a:latin typeface="Times New Roman"/>
                          <a:ea typeface="SimSun"/>
                        </a:rPr>
                        <a:t>Ubi-Pro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" name=""/>
                    <p:cNvSpPr/>
                    <p:nvPr/>
                  </p:nvSpPr>
                  <p:spPr>
                    <a:xfrm>
                      <a:off x="4815000" y="2650320"/>
                      <a:ext cx="849240" cy="2250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64800" rIns="64800" tIns="32400" bIns="324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cc3300"/>
                          </a:solidFill>
                          <a:latin typeface="Times New Roman"/>
                          <a:ea typeface="SimSun"/>
                        </a:rPr>
                        <a:t>pCAMBIA1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" name=""/>
                    <p:cNvSpPr/>
                    <p:nvPr/>
                  </p:nvSpPr>
                  <p:spPr>
                    <a:xfrm>
                      <a:off x="2548440" y="2586600"/>
                      <a:ext cx="1186560" cy="397440"/>
                    </a:xfrm>
                    <a:prstGeom prst="rightArrow">
                      <a:avLst>
                        <a:gd name="adj1" fmla="val 50000"/>
                        <a:gd name="adj2" fmla="val 74638"/>
                      </a:avLst>
                    </a:prstGeom>
                    <a:solidFill>
                      <a:srgbClr val="bbe0e3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64800" rIns="64800" tIns="32400" bIns="324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100" spc="-1" strike="noStrike">
                          <a:solidFill>
                            <a:srgbClr val="ff00ff"/>
                          </a:solidFill>
                          <a:latin typeface="Times New Roman"/>
                          <a:ea typeface="SimSun"/>
                        </a:rPr>
                        <a:t>OsCYP96B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" name=""/>
                    <p:cNvSpPr/>
                    <p:nvPr/>
                  </p:nvSpPr>
                  <p:spPr>
                    <a:xfrm>
                      <a:off x="2346480" y="2305800"/>
                      <a:ext cx="514080" cy="2250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64800" rIns="64800" tIns="32400" bIns="324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800" spc="-1" strike="noStrike">
                          <a:solidFill>
                            <a:srgbClr val="33cc33"/>
                          </a:solidFill>
                          <a:latin typeface="Times New Roman"/>
                          <a:ea typeface="SimSun"/>
                        </a:rPr>
                        <a:t>Bam</a:t>
                      </a:r>
                      <a:r>
                        <a:rPr b="1" lang="en-US" sz="800" spc="-1" strike="noStrike">
                          <a:solidFill>
                            <a:srgbClr val="33cc33"/>
                          </a:solidFill>
                          <a:latin typeface="Times New Roman"/>
                          <a:ea typeface="SimSun"/>
                        </a:rPr>
                        <a:t>H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" name=""/>
                    <p:cNvSpPr/>
                    <p:nvPr/>
                  </p:nvSpPr>
                  <p:spPr>
                    <a:xfrm>
                      <a:off x="4466520" y="2223720"/>
                      <a:ext cx="813600" cy="263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64800" rIns="64800" tIns="32400" bIns="324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100" spc="-1" strike="noStrike">
                          <a:solidFill>
                            <a:srgbClr val="ff3300"/>
                          </a:solidFill>
                          <a:latin typeface="Times New Roman"/>
                          <a:ea typeface="SimSun"/>
                        </a:rPr>
                        <a:t>NOS </a:t>
                      </a:r>
                      <a:r>
                        <a:rPr b="1" lang="en-US" sz="1300" spc="-1" strike="noStrike">
                          <a:solidFill>
                            <a:srgbClr val="ff3300"/>
                          </a:solidFill>
                          <a:latin typeface="Times New Roman"/>
                          <a:ea typeface="SimSun"/>
                        </a:rPr>
                        <a:t>Term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" name=""/>
                    <p:cNvSpPr/>
                    <p:nvPr/>
                  </p:nvSpPr>
                  <p:spPr>
                    <a:xfrm>
                      <a:off x="4082400" y="2952000"/>
                      <a:ext cx="393840" cy="260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64800" rIns="64800" tIns="32400" bIns="324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800" spc="-1" strike="noStrike">
                          <a:solidFill>
                            <a:srgbClr val="33cc33"/>
                          </a:solidFill>
                          <a:latin typeface="Times New Roman"/>
                          <a:ea typeface="SimSun"/>
                        </a:rPr>
                        <a:t>Sac</a:t>
                      </a:r>
                      <a:r>
                        <a:rPr b="1" lang="en-US" sz="800" spc="-1" strike="noStrike">
                          <a:solidFill>
                            <a:srgbClr val="33cc33"/>
                          </a:solidFill>
                          <a:latin typeface="Times New Roman"/>
                          <a:ea typeface="SimSun"/>
                        </a:rPr>
                        <a:t>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" name=""/>
                    <p:cNvSpPr/>
                    <p:nvPr/>
                  </p:nvSpPr>
                  <p:spPr>
                    <a:xfrm flipV="1">
                      <a:off x="1013400" y="2478960"/>
                      <a:ext cx="0" cy="274680"/>
                    </a:xfrm>
                    <a:prstGeom prst="line">
                      <a:avLst/>
                    </a:prstGeom>
                    <a:ln w="38160">
                      <a:solidFill>
                        <a:srgbClr val="ff99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1" name=""/>
                    <p:cNvSpPr/>
                    <p:nvPr/>
                  </p:nvSpPr>
                  <p:spPr>
                    <a:xfrm flipV="1">
                      <a:off x="2523600" y="2486520"/>
                      <a:ext cx="0" cy="275040"/>
                    </a:xfrm>
                    <a:prstGeom prst="line">
                      <a:avLst/>
                    </a:prstGeom>
                    <a:ln w="38160">
                      <a:solidFill>
                        <a:srgbClr val="ff99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" name=""/>
                    <p:cNvSpPr/>
                    <p:nvPr/>
                  </p:nvSpPr>
                  <p:spPr>
                    <a:xfrm flipV="1">
                      <a:off x="3734280" y="2478960"/>
                      <a:ext cx="0" cy="274680"/>
                    </a:xfrm>
                    <a:prstGeom prst="line">
                      <a:avLst/>
                    </a:prstGeom>
                    <a:ln w="38160">
                      <a:solidFill>
                        <a:srgbClr val="ff99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" name=""/>
                    <p:cNvSpPr/>
                    <p:nvPr/>
                  </p:nvSpPr>
                  <p:spPr>
                    <a:xfrm flipV="1">
                      <a:off x="4286880" y="2808720"/>
                      <a:ext cx="0" cy="219960"/>
                    </a:xfrm>
                    <a:prstGeom prst="line">
                      <a:avLst/>
                    </a:prstGeom>
                    <a:ln w="38160">
                      <a:solidFill>
                        <a:srgbClr val="ff99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84" name=""/>
                  <p:cNvGrpSpPr/>
                  <p:nvPr/>
                </p:nvGrpSpPr>
                <p:grpSpPr>
                  <a:xfrm>
                    <a:off x="3753360" y="2617560"/>
                    <a:ext cx="512640" cy="301680"/>
                    <a:chOff x="3753360" y="2617560"/>
                    <a:chExt cx="512640" cy="301680"/>
                  </a:xfrm>
                </p:grpSpPr>
                <p:sp>
                  <p:nvSpPr>
                    <p:cNvPr id="85" name=""/>
                    <p:cNvSpPr/>
                    <p:nvPr/>
                  </p:nvSpPr>
                  <p:spPr>
                    <a:xfrm>
                      <a:off x="3753360" y="2617560"/>
                      <a:ext cx="149040" cy="301680"/>
                    </a:xfrm>
                    <a:prstGeom prst="rect">
                      <a:avLst/>
                    </a:prstGeom>
                    <a:solidFill>
                      <a:srgbClr val="cc330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" name=""/>
                    <p:cNvSpPr/>
                    <p:nvPr/>
                  </p:nvSpPr>
                  <p:spPr>
                    <a:xfrm>
                      <a:off x="3902400" y="2617560"/>
                      <a:ext cx="363600" cy="301680"/>
                    </a:xfrm>
                    <a:prstGeom prst="rect">
                      <a:avLst/>
                    </a:prstGeom>
                    <a:solidFill>
                      <a:srgbClr val="ff330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</p:grpSp>
        <p:grpSp>
          <p:nvGrpSpPr>
            <p:cNvPr id="87" name=""/>
            <p:cNvGrpSpPr/>
            <p:nvPr/>
          </p:nvGrpSpPr>
          <p:grpSpPr>
            <a:xfrm>
              <a:off x="762120" y="3134880"/>
              <a:ext cx="4960080" cy="878040"/>
              <a:chOff x="762120" y="3134880"/>
              <a:chExt cx="4960080" cy="878040"/>
            </a:xfrm>
          </p:grpSpPr>
          <p:sp>
            <p:nvSpPr>
              <p:cNvPr id="88" name=""/>
              <p:cNvSpPr/>
              <p:nvPr/>
            </p:nvSpPr>
            <p:spPr>
              <a:xfrm>
                <a:off x="770760" y="3134880"/>
                <a:ext cx="285120" cy="229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58680" rIns="58680" tIns="29160" bIns="29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(C)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9" name=""/>
              <p:cNvGrpSpPr/>
              <p:nvPr/>
            </p:nvGrpSpPr>
            <p:grpSpPr>
              <a:xfrm>
                <a:off x="862920" y="3776760"/>
                <a:ext cx="3970800" cy="68040"/>
                <a:chOff x="862920" y="3776760"/>
                <a:chExt cx="3970800" cy="68040"/>
              </a:xfrm>
            </p:grpSpPr>
            <p:sp>
              <p:nvSpPr>
                <p:cNvPr id="90" name=""/>
                <p:cNvSpPr/>
                <p:nvPr/>
              </p:nvSpPr>
              <p:spPr>
                <a:xfrm>
                  <a:off x="862920" y="3844440"/>
                  <a:ext cx="3970800" cy="360"/>
                </a:xfrm>
                <a:prstGeom prst="line">
                  <a:avLst/>
                </a:prstGeom>
                <a:ln w="93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862920" y="3776760"/>
                  <a:ext cx="3970800" cy="360"/>
                </a:xfrm>
                <a:prstGeom prst="line">
                  <a:avLst/>
                </a:prstGeom>
                <a:ln w="93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2" name=""/>
              <p:cNvSpPr/>
              <p:nvPr/>
            </p:nvSpPr>
            <p:spPr>
              <a:xfrm>
                <a:off x="1014120" y="3617280"/>
                <a:ext cx="1516320" cy="394200"/>
              </a:xfrm>
              <a:prstGeom prst="rightArrow">
                <a:avLst>
                  <a:gd name="adj1" fmla="val 50000"/>
                  <a:gd name="adj2" fmla="val 96164"/>
                </a:avLst>
              </a:prstGeom>
              <a:solidFill>
                <a:srgbClr val="00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4800" rIns="64800" tIns="32400" bIns="324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762120" y="3327120"/>
                <a:ext cx="535680" cy="238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4800" rIns="64800" tIns="32400" bIns="32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33cc33"/>
                    </a:solidFill>
                    <a:latin typeface="Times New Roman"/>
                    <a:ea typeface="SimSun"/>
                  </a:rPr>
                  <a:t>Hin</a:t>
                </a:r>
                <a:r>
                  <a:rPr b="1" lang="en-US" sz="800" spc="-1" strike="noStrike">
                    <a:solidFill>
                      <a:srgbClr val="33cc33"/>
                    </a:solidFill>
                    <a:latin typeface="Times New Roman"/>
                    <a:ea typeface="SimSun"/>
                  </a:rPr>
                  <a:t>dII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788720" y="3679560"/>
                <a:ext cx="933480" cy="225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4800" rIns="64800" tIns="32400" bIns="32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cc3300"/>
                    </a:solidFill>
                    <a:latin typeface="Times New Roman"/>
                    <a:ea typeface="SimSun"/>
                  </a:rPr>
                  <a:t>pCAMBIA13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514240" y="3615480"/>
                <a:ext cx="1203840" cy="397440"/>
              </a:xfrm>
              <a:prstGeom prst="rightArrow">
                <a:avLst>
                  <a:gd name="adj1" fmla="val 50000"/>
                  <a:gd name="adj2" fmla="val 75725"/>
                </a:avLst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4800" rIns="64800" tIns="32400" bIns="324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100" spc="-1" strike="noStrike">
                    <a:solidFill>
                      <a:srgbClr val="ff00ff"/>
                    </a:solidFill>
                    <a:latin typeface="Times New Roman"/>
                    <a:ea typeface="SimSun"/>
                  </a:rPr>
                  <a:t>OsCYP96B4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702240" y="3655440"/>
                <a:ext cx="595440" cy="309600"/>
              </a:xfrm>
              <a:prstGeom prst="rect">
                <a:avLst/>
              </a:prstGeom>
              <a:solidFill>
                <a:srgbClr val="ff33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4800" rIns="64800" tIns="32400" bIns="324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66"/>
                    </a:solidFill>
                    <a:latin typeface="Times New Roman"/>
                    <a:ea typeface="SimSun"/>
                  </a:rPr>
                  <a:t>3’UT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4088880" y="3299760"/>
                <a:ext cx="431640" cy="276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4800" rIns="64800" tIns="32400" bIns="324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33cc33"/>
                    </a:solidFill>
                    <a:latin typeface="Times New Roman"/>
                    <a:ea typeface="SimSun"/>
                  </a:rPr>
                  <a:t>Sac</a:t>
                </a:r>
                <a:r>
                  <a:rPr b="1" lang="en-US" sz="800" spc="-1" strike="noStrike">
                    <a:solidFill>
                      <a:srgbClr val="33cc33"/>
                    </a:solidFill>
                    <a:latin typeface="Times New Roman"/>
                    <a:ea typeface="SimSun"/>
                  </a:rPr>
                  <a:t>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1065600" y="3689280"/>
                <a:ext cx="1178640" cy="27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4800" rIns="64800" tIns="32400" bIns="32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100" spc="-1" strike="noStrike">
                    <a:solidFill>
                      <a:srgbClr val="ffff66"/>
                    </a:solidFill>
                    <a:latin typeface="Times New Roman"/>
                    <a:ea typeface="SimSun"/>
                  </a:rPr>
                  <a:t>OsCYP96B4</a:t>
                </a:r>
                <a:r>
                  <a:rPr b="1" lang="en-US" sz="1100" spc="-1" strike="noStrike">
                    <a:solidFill>
                      <a:srgbClr val="ffff66"/>
                    </a:solidFill>
                    <a:latin typeface="Times New Roman"/>
                    <a:ea typeface="SimSun"/>
                  </a:rPr>
                  <a:t>-Pro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578680" y="3322800"/>
                <a:ext cx="406440" cy="232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4800" rIns="64800" tIns="32400" bIns="32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33cc33"/>
                    </a:solidFill>
                    <a:latin typeface="Times New Roman"/>
                    <a:ea typeface="SimSun"/>
                  </a:rPr>
                  <a:t>Nar</a:t>
                </a:r>
                <a:r>
                  <a:rPr b="1" lang="en-US" sz="800" spc="-1" strike="noStrike">
                    <a:solidFill>
                      <a:srgbClr val="33cc33"/>
                    </a:solidFill>
                    <a:latin typeface="Times New Roman"/>
                    <a:ea typeface="SimSun"/>
                  </a:rPr>
                  <a:t>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3667680" y="3327120"/>
                <a:ext cx="415080" cy="238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4800" rIns="64800" tIns="32400" bIns="32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33cc33"/>
                    </a:solidFill>
                    <a:latin typeface="Times New Roman"/>
                    <a:ea typeface="SimSun"/>
                  </a:rPr>
                  <a:t>Sph</a:t>
                </a:r>
                <a:r>
                  <a:rPr b="1" lang="en-US" sz="800" spc="-1" strike="noStrike">
                    <a:solidFill>
                      <a:srgbClr val="33cc33"/>
                    </a:solidFill>
                    <a:latin typeface="Times New Roman"/>
                    <a:ea typeface="SimSun"/>
                  </a:rPr>
                  <a:t>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 flipV="1">
                <a:off x="995040" y="3508560"/>
                <a:ext cx="0" cy="281160"/>
              </a:xfrm>
              <a:prstGeom prst="line">
                <a:avLst/>
              </a:prstGeom>
              <a:ln w="38160">
                <a:solidFill>
                  <a:srgbClr val="ff9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2732400" y="3484080"/>
                <a:ext cx="0" cy="225360"/>
              </a:xfrm>
              <a:prstGeom prst="line">
                <a:avLst/>
              </a:prstGeom>
              <a:ln w="38160">
                <a:solidFill>
                  <a:srgbClr val="ff9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 flipV="1">
                <a:off x="3844800" y="3493800"/>
                <a:ext cx="720" cy="168840"/>
              </a:xfrm>
              <a:prstGeom prst="line">
                <a:avLst/>
              </a:prstGeom>
              <a:ln w="38160">
                <a:solidFill>
                  <a:srgbClr val="ff9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V="1">
                <a:off x="4309920" y="3473280"/>
                <a:ext cx="720" cy="316800"/>
              </a:xfrm>
              <a:prstGeom prst="line">
                <a:avLst/>
              </a:prstGeom>
              <a:ln w="38160">
                <a:solidFill>
                  <a:srgbClr val="ff9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5" name=""/>
            <p:cNvGrpSpPr/>
            <p:nvPr/>
          </p:nvGrpSpPr>
          <p:grpSpPr>
            <a:xfrm>
              <a:off x="762120" y="4174560"/>
              <a:ext cx="5057640" cy="981360"/>
              <a:chOff x="762120" y="4174560"/>
              <a:chExt cx="5057640" cy="981360"/>
            </a:xfrm>
          </p:grpSpPr>
          <p:sp>
            <p:nvSpPr>
              <p:cNvPr id="106" name=""/>
              <p:cNvSpPr/>
              <p:nvPr/>
            </p:nvSpPr>
            <p:spPr>
              <a:xfrm>
                <a:off x="770760" y="4174560"/>
                <a:ext cx="285120" cy="22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58680" rIns="58680" tIns="29160" bIns="29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(D)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7" name=""/>
              <p:cNvGrpSpPr/>
              <p:nvPr/>
            </p:nvGrpSpPr>
            <p:grpSpPr>
              <a:xfrm>
                <a:off x="762120" y="4420080"/>
                <a:ext cx="5057640" cy="735840"/>
                <a:chOff x="762120" y="4420080"/>
                <a:chExt cx="5057640" cy="735840"/>
              </a:xfrm>
            </p:grpSpPr>
            <p:sp>
              <p:nvSpPr>
                <p:cNvPr id="108" name=""/>
                <p:cNvSpPr/>
                <p:nvPr/>
              </p:nvSpPr>
              <p:spPr>
                <a:xfrm>
                  <a:off x="3435120" y="4423680"/>
                  <a:ext cx="398160" cy="235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Kpn</a:t>
                  </a:r>
                  <a:r>
                    <a:rPr b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762120" y="4423680"/>
                  <a:ext cx="529560" cy="239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Hin</a:t>
                  </a:r>
                  <a:r>
                    <a:rPr b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dII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0" name=""/>
                <p:cNvGrpSpPr/>
                <p:nvPr/>
              </p:nvGrpSpPr>
              <p:grpSpPr>
                <a:xfrm>
                  <a:off x="862200" y="4909680"/>
                  <a:ext cx="4096440" cy="56880"/>
                  <a:chOff x="862200" y="4909680"/>
                  <a:chExt cx="4096440" cy="56880"/>
                </a:xfrm>
              </p:grpSpPr>
              <p:sp>
                <p:nvSpPr>
                  <p:cNvPr id="111" name=""/>
                  <p:cNvSpPr/>
                  <p:nvPr/>
                </p:nvSpPr>
                <p:spPr>
                  <a:xfrm>
                    <a:off x="862200" y="4966560"/>
                    <a:ext cx="4096440" cy="0"/>
                  </a:xfrm>
                  <a:prstGeom prst="line">
                    <a:avLst/>
                  </a:prstGeom>
                  <a:ln w="9360">
                    <a:solidFill>
                      <a:srgbClr val="ff99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" name=""/>
                  <p:cNvSpPr/>
                  <p:nvPr/>
                </p:nvSpPr>
                <p:spPr>
                  <a:xfrm>
                    <a:off x="862200" y="4909680"/>
                    <a:ext cx="4096440" cy="0"/>
                  </a:xfrm>
                  <a:prstGeom prst="line">
                    <a:avLst/>
                  </a:prstGeom>
                  <a:ln w="9360">
                    <a:solidFill>
                      <a:srgbClr val="ff99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13" name=""/>
                <p:cNvSpPr/>
                <p:nvPr/>
              </p:nvSpPr>
              <p:spPr>
                <a:xfrm>
                  <a:off x="1020240" y="4708080"/>
                  <a:ext cx="1339200" cy="447840"/>
                </a:xfrm>
                <a:prstGeom prst="rightArrow">
                  <a:avLst>
                    <a:gd name="adj1" fmla="val 50000"/>
                    <a:gd name="adj2" fmla="val 74759"/>
                  </a:avLst>
                </a:prstGeom>
                <a:solidFill>
                  <a:srgbClr val="00cc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ffff66"/>
                      </a:solidFill>
                      <a:latin typeface="Times New Roman"/>
                      <a:ea typeface="SimSun"/>
                    </a:rPr>
                    <a:t>Ubi-Pro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4861800" y="4795200"/>
                  <a:ext cx="957960" cy="259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cc3300"/>
                      </a:solidFill>
                      <a:latin typeface="Times New Roman"/>
                      <a:ea typeface="SimSun"/>
                    </a:rPr>
                    <a:t>pCAMBIA13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2386080" y="4726080"/>
                  <a:ext cx="1190160" cy="423000"/>
                </a:xfrm>
                <a:prstGeom prst="rightArrow">
                  <a:avLst>
                    <a:gd name="adj1" fmla="val 50000"/>
                    <a:gd name="adj2" fmla="val 70340"/>
                  </a:avLst>
                </a:prstGeom>
                <a:solidFill>
                  <a:srgbClr val="bbe0e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100" spc="-1" strike="noStrike">
                      <a:solidFill>
                        <a:srgbClr val="ff00ff"/>
                      </a:solidFill>
                      <a:latin typeface="Times New Roman"/>
                      <a:ea typeface="SimSun"/>
                    </a:rPr>
                    <a:t>OsCYP96B4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2174040" y="4423680"/>
                  <a:ext cx="494280" cy="231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Bam</a:t>
                  </a:r>
                  <a:r>
                    <a:rPr b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H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 flipV="1">
                  <a:off x="995040" y="4604760"/>
                  <a:ext cx="0" cy="284400"/>
                </a:xfrm>
                <a:prstGeom prst="line">
                  <a:avLst/>
                </a:prstGeom>
                <a:ln w="381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 flipV="1">
                  <a:off x="2351880" y="4611240"/>
                  <a:ext cx="360" cy="284400"/>
                </a:xfrm>
                <a:prstGeom prst="line">
                  <a:avLst/>
                </a:prstGeom>
                <a:ln w="381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 flipV="1">
                  <a:off x="3584160" y="4594680"/>
                  <a:ext cx="360" cy="285120"/>
                </a:xfrm>
                <a:prstGeom prst="line">
                  <a:avLst/>
                </a:prstGeom>
                <a:ln w="381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4275000" y="4771080"/>
                  <a:ext cx="524160" cy="285120"/>
                </a:xfrm>
                <a:prstGeom prst="rect">
                  <a:avLst/>
                </a:prstGeom>
                <a:solidFill>
                  <a:srgbClr val="ff3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300" spc="-1" strike="noStrike">
                      <a:solidFill>
                        <a:srgbClr val="ffff66"/>
                      </a:solidFill>
                      <a:latin typeface="Times New Roman"/>
                      <a:ea typeface="SimSun"/>
                    </a:rPr>
                    <a:t>NOS</a:t>
                  </a:r>
                  <a:endParaRPr b="0" lang="en-US" sz="13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3593160" y="4744440"/>
                  <a:ext cx="674280" cy="363960"/>
                </a:xfrm>
                <a:prstGeom prst="rightArrow">
                  <a:avLst>
                    <a:gd name="adj1" fmla="val 50000"/>
                    <a:gd name="adj2" fmla="val 46316"/>
                  </a:avLst>
                </a:prstGeom>
                <a:solidFill>
                  <a:srgbClr val="99ff3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300" spc="-1" strike="noStrike">
                      <a:solidFill>
                        <a:srgbClr val="ff00ff"/>
                      </a:solidFill>
                      <a:latin typeface="Times New Roman"/>
                      <a:ea typeface="SimSun"/>
                    </a:rPr>
                    <a:t>sGFP</a:t>
                  </a:r>
                  <a:endParaRPr b="0" lang="en-US" sz="13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>
                  <a:off x="4666320" y="4420080"/>
                  <a:ext cx="332280" cy="241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Sac</a:t>
                  </a:r>
                  <a:r>
                    <a:rPr b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 flipV="1">
                  <a:off x="4823640" y="4610160"/>
                  <a:ext cx="360" cy="284760"/>
                </a:xfrm>
                <a:prstGeom prst="line">
                  <a:avLst/>
                </a:prstGeom>
                <a:ln w="381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4128480" y="4438080"/>
                  <a:ext cx="340560" cy="223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4800" rIns="64800" tIns="32400" bIns="324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Not</a:t>
                  </a:r>
                  <a:r>
                    <a:rPr b="1" lang="en-US" sz="800" spc="-1" strike="noStrike">
                      <a:solidFill>
                        <a:srgbClr val="33cc33"/>
                      </a:solidFill>
                      <a:latin typeface="Times New Roman"/>
                      <a:ea typeface="SimSun"/>
                    </a:rPr>
                    <a:t>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 flipV="1">
                  <a:off x="4260240" y="4600080"/>
                  <a:ext cx="360" cy="284760"/>
                </a:xfrm>
                <a:prstGeom prst="line">
                  <a:avLst/>
                </a:prstGeom>
                <a:ln w="38160">
                  <a:solidFill>
                    <a:srgbClr val="ff99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126" name=""/>
          <p:cNvSpPr/>
          <p:nvPr/>
        </p:nvSpPr>
        <p:spPr>
          <a:xfrm>
            <a:off x="762120" y="609480"/>
            <a:ext cx="213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orting Figure 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762120" y="5486400"/>
            <a:ext cx="51051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orting Figure S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Constructs for promoter, ectopic/over-expression, complementation analysis. (A)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OsCYP96B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promoter sGFP fusion. (B) Ectopic-expression. (C) Complementation and over-expression. (D)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OsCYP96B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cDNA-sGFP fus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4T08:13:41Z</dcterms:created>
  <dc:creator>shuye</dc:creator>
  <dc:description/>
  <dc:language>en-US</dc:language>
  <cp:lastModifiedBy>shuye</cp:lastModifiedBy>
  <dcterms:modified xsi:type="dcterms:W3CDTF">2011-08-16T07:38:38Z</dcterms:modified>
  <cp:revision>10</cp:revision>
  <dc:subject/>
  <dc:title>Slide 1</dc:title>
</cp:coreProperties>
</file>